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32" r:id="rId1"/>
  </p:sldMasterIdLst>
  <p:notesMasterIdLst>
    <p:notesMasterId r:id="rId3"/>
  </p:notesMasterIdLst>
  <p:sldIdLst>
    <p:sldId id="298" r:id="rId2"/>
  </p:sldIdLst>
  <p:sldSz cx="7559675" cy="10439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7EFDE27-64D2-9A47-7EBA-F4D877437D86}" name="Crevel, Reinout van" initials="" userId="S::Reinout.vanCrevel@radboudumc.nl::c8a85eab-04e2-4374-80ac-ff56393b1662" providerId="AD"/>
  <p188:author id="{0A69D33C-A3AE-B2FD-DAE3-489C6085493B}" name="Setiabudiawan, Todia" initials="TS" userId="S::Todia.Setiabudiawan@radboudumc.nl::b66113ee-6b80-4b22-902e-4e4411cc18e9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7335"/>
    <p:restoredTop sz="94720"/>
  </p:normalViewPr>
  <p:slideViewPr>
    <p:cSldViewPr snapToGrid="0">
      <p:cViewPr varScale="1">
        <p:scale>
          <a:sx n="67" d="100"/>
          <a:sy n="67" d="100"/>
        </p:scale>
        <p:origin x="240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ED36B6E-0244-7342-9A93-7D998A0B8A7C}" type="datetimeFigureOut">
              <a:rPr lang="en-US" smtClean="0"/>
              <a:t>3/30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11400" y="1143000"/>
            <a:ext cx="22352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6B7A9C-8B5B-7A4D-836E-05FD47B04D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4364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08486"/>
            <a:ext cx="6425724" cy="3634458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483102"/>
            <a:ext cx="5669756" cy="2520438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0113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27770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55801"/>
            <a:ext cx="1630055" cy="8846909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55801"/>
            <a:ext cx="4795669" cy="8846909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88843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5521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02603"/>
            <a:ext cx="6520220" cy="4342500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6986185"/>
            <a:ext cx="6520220" cy="2283618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>
                    <a:tint val="82000"/>
                  </a:schemeClr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82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82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71163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779007"/>
            <a:ext cx="3212862" cy="662370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779007"/>
            <a:ext cx="3212862" cy="662370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37483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55804"/>
            <a:ext cx="6520220" cy="2017801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559104"/>
            <a:ext cx="3198096" cy="1254177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813281"/>
            <a:ext cx="3198096" cy="560876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559104"/>
            <a:ext cx="3213847" cy="1254177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813281"/>
            <a:ext cx="3213847" cy="560876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91291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45652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2888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95960"/>
            <a:ext cx="2438192" cy="2435860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03083"/>
            <a:ext cx="3827085" cy="7418740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131820"/>
            <a:ext cx="2438192" cy="5802084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22123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95960"/>
            <a:ext cx="2438192" cy="2435860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03083"/>
            <a:ext cx="3827085" cy="7418740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131820"/>
            <a:ext cx="2438192" cy="5802084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88030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55804"/>
            <a:ext cx="6520220" cy="20178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779007"/>
            <a:ext cx="6520220" cy="66237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675780"/>
            <a:ext cx="1700927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675780"/>
            <a:ext cx="2551390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675780"/>
            <a:ext cx="1700927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24421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E608059-390D-47D3-CDC4-8CDE2D08220B}"/>
              </a:ext>
            </a:extLst>
          </p:cNvPr>
          <p:cNvSpPr txBox="1"/>
          <p:nvPr/>
        </p:nvSpPr>
        <p:spPr>
          <a:xfrm>
            <a:off x="161148" y="8909849"/>
            <a:ext cx="723737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NZ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Inferred regulatory strength of selected transcriptional regulators in L2-B- and L4-infected lungs.</a:t>
            </a:r>
            <a:br>
              <a:rPr lang="en-NZ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Picture 7" descr="A close-up of a graph&#10;&#10;Description automatically generated">
            <a:extLst>
              <a:ext uri="{FF2B5EF4-FFF2-40B4-BE49-F238E27FC236}">
                <a16:creationId xmlns:a16="http://schemas.microsoft.com/office/drawing/2014/main" id="{1D1EE792-FCD6-4D6A-E758-8962E3454C6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51460" y="0"/>
            <a:ext cx="3148853" cy="89419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254778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948</TotalTime>
  <Words>18</Words>
  <Application>Microsoft Macintosh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aomi Daniels</dc:creator>
  <cp:lastModifiedBy>Naomi Daniels</cp:lastModifiedBy>
  <cp:revision>5</cp:revision>
  <dcterms:created xsi:type="dcterms:W3CDTF">2025-04-08T03:28:33Z</dcterms:created>
  <dcterms:modified xsi:type="dcterms:W3CDTF">2026-03-30T03:31:35Z</dcterms:modified>
</cp:coreProperties>
</file>